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  <p:sldId id="262" r:id="rId3"/>
    <p:sldId id="263" r:id="rId4"/>
    <p:sldId id="264" r:id="rId5"/>
    <p:sldId id="265" r:id="rId6"/>
    <p:sldId id="266" r:id="rId7"/>
    <p:sldId id="267" r:id="rId8"/>
    <p:sldId id="268" r:id="rId9"/>
    <p:sldId id="269" r:id="rId10"/>
    <p:sldId id="270" r:id="rId11"/>
    <p:sldId id="271" r:id="rId12"/>
    <p:sldId id="272" r:id="rId1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Jennifer Yee" initials="JY" lastIdx="1" clrIdx="0">
    <p:extLst>
      <p:ext uri="{19B8F6BF-5375-455C-9EA6-DF929625EA0E}">
        <p15:presenceInfo xmlns:p15="http://schemas.microsoft.com/office/powerpoint/2012/main" userId="3a1b47abb8a934fb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024" autoAdjust="0"/>
    <p:restoredTop sz="94660"/>
  </p:normalViewPr>
  <p:slideViewPr>
    <p:cSldViewPr snapToGrid="0">
      <p:cViewPr varScale="1">
        <p:scale>
          <a:sx n="73" d="100"/>
          <a:sy n="73" d="100"/>
        </p:scale>
        <p:origin x="252" y="2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commentAuthors" Target="commentAuthor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E650D9B-9CDC-429E-B923-DE285028CF8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8F86244-8FDA-414D-BCB3-A4685141D20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5DD1556-2C04-405B-BE5A-B6DBC79AA3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17B4B0-D1E1-468B-B0F9-E5B5442CE62E}" type="datetimeFigureOut">
              <a:rPr lang="en-US" smtClean="0"/>
              <a:t>2/20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1E6DE4F-2A30-4404-9676-BF0AE3D8C0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666D6B8-0589-479C-9EDD-201D2433DC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13D433-04EB-4BF7-93B2-BEAB288882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73113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2842E6-23BA-40DB-BEDD-9C74400545E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E5DCDF8-D06A-4EE1-8DDD-6BE91B181FB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CED1976-E1E0-489B-A628-D51D2E1353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17B4B0-D1E1-468B-B0F9-E5B5442CE62E}" type="datetimeFigureOut">
              <a:rPr lang="en-US" smtClean="0"/>
              <a:t>2/20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7F098CE-0378-470F-8383-4D3B67831A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73BB9C5-7DAD-477C-8D56-2E2FC0AEE1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13D433-04EB-4BF7-93B2-BEAB288882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25844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4DDD76D-13B5-485B-9E9A-D9597976223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9B10B3D-296E-4B3F-B2FE-8235552676C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66FE7A9-A1B7-4CBF-93CE-67BCC2EB78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17B4B0-D1E1-468B-B0F9-E5B5442CE62E}" type="datetimeFigureOut">
              <a:rPr lang="en-US" smtClean="0"/>
              <a:t>2/20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0A0802C-5AB0-465C-A907-44A2A7DE96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BE353B1-4921-4906-A488-AA5083CD74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13D433-04EB-4BF7-93B2-BEAB288882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5050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C89BE1-E9D1-4EE9-B154-884157F8161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2A78121-25AF-4C44-B976-0DE85D3510D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283BD6F-1DC2-494D-8F04-035C15030F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17B4B0-D1E1-468B-B0F9-E5B5442CE62E}" type="datetimeFigureOut">
              <a:rPr lang="en-US" smtClean="0"/>
              <a:t>2/20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D5A10C2-2C15-43FA-9E4D-4004C6DA87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28B40AE-AE99-4369-894B-FD73CFA699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13D433-04EB-4BF7-93B2-BEAB288882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73153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892F30B-592E-46A1-BDB4-9276A3F1D2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8DD62EF-8EA5-4A5C-99E7-23B6F519349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2609A64-BE82-434D-9E27-EEF426E948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17B4B0-D1E1-468B-B0F9-E5B5442CE62E}" type="datetimeFigureOut">
              <a:rPr lang="en-US" smtClean="0"/>
              <a:t>2/20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710C7CE-E2D9-49D0-8B0F-81792473B7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82C4486-1BC3-4BDB-B8B9-2804A38310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13D433-04EB-4BF7-93B2-BEAB288882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48351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6181BED-4752-41B8-A075-B40C591E44D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223EA46-D2EB-4A4F-82FA-9635A0BBA6F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4611962-09D7-4CEA-9A62-3CF7A7BC5D9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66CE175-30BC-4E53-8F3D-B38463C65C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17B4B0-D1E1-468B-B0F9-E5B5442CE62E}" type="datetimeFigureOut">
              <a:rPr lang="en-US" smtClean="0"/>
              <a:t>2/20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AD6913F-58FF-4961-9C34-9132C11A65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B55D020-03FC-46E8-B0B0-57706EC042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13D433-04EB-4BF7-93B2-BEAB288882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72465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38343A-4359-4BCF-AE20-1A1CE1F065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8F385BD-DE78-40BC-AE95-18DF32E8790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C39A9CE-C423-48FA-9B8E-4374362AE8F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7A420D2-CD30-4A1A-8E2B-BB1CEA13DF7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0D89486-7899-43F8-9393-26B9C221D2A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89C61CD-D911-4AD5-A219-CA2F1886A3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17B4B0-D1E1-468B-B0F9-E5B5442CE62E}" type="datetimeFigureOut">
              <a:rPr lang="en-US" smtClean="0"/>
              <a:t>2/20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9964422-9BE0-4D3A-B07C-14BAF75B3C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9F719B9-0D27-400F-97F8-F7EE0E0FCF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13D433-04EB-4BF7-93B2-BEAB288882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11677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F21A35-AE64-490F-BE96-833318540EE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01165D4-3091-4CAE-9521-ABD62E2212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17B4B0-D1E1-468B-B0F9-E5B5442CE62E}" type="datetimeFigureOut">
              <a:rPr lang="en-US" smtClean="0"/>
              <a:t>2/20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0E11103-717B-4516-BE1A-8888FAE848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8360084-9768-45F2-B0A8-8D27CA2BD5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13D433-04EB-4BF7-93B2-BEAB288882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36361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6F181E6-A7B3-4D43-BA27-B729EF04EF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17B4B0-D1E1-468B-B0F9-E5B5442CE62E}" type="datetimeFigureOut">
              <a:rPr lang="en-US" smtClean="0"/>
              <a:t>2/20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DC42B03-CE70-49A5-9174-B6BA78DED9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F3DCD91-BCBD-4718-B0BC-4EBF990445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13D433-04EB-4BF7-93B2-BEAB288882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63908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4512960-1944-48BD-BBEC-9F5B9AC6F1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76F7362-0D33-439E-9345-B1DFE3B4E57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FD45741-0C5A-44BE-8997-F5D90371903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C6BBB1C-2325-4465-8670-8A985CDBCC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17B4B0-D1E1-468B-B0F9-E5B5442CE62E}" type="datetimeFigureOut">
              <a:rPr lang="en-US" smtClean="0"/>
              <a:t>2/20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9F587C0-26E7-4D29-B527-F662B8FB58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476837C-DA9E-4B2E-9C06-313F608575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13D433-04EB-4BF7-93B2-BEAB288882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23634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CE3A0E-142C-46D8-9669-34478BCC88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714FD8E-CFFB-4877-83C4-4C2576214AE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729624A-BEC1-4088-9DB8-9C032D53B77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40B7480-CA54-41DF-B331-E18D0564CE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17B4B0-D1E1-468B-B0F9-E5B5442CE62E}" type="datetimeFigureOut">
              <a:rPr lang="en-US" smtClean="0"/>
              <a:t>2/20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8CEDDDA-BCC0-47CD-A484-825C1CA17E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1045702-7961-4C2B-B668-B8CFEC76E2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13D433-04EB-4BF7-93B2-BEAB288882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28933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DE28635-7E79-4C81-81A4-A1B5CE0AAA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1363B4A-B5A6-4FE6-9610-91E9436E449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DB1D2A6-89B0-4743-BE5B-C0DE8BBF45F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17B4B0-D1E1-468B-B0F9-E5B5442CE62E}" type="datetimeFigureOut">
              <a:rPr lang="en-US" smtClean="0"/>
              <a:t>2/20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7EAF4EC-6CC5-4C72-8A12-C1811529116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EE70A59-A8B1-4F48-8B07-A60E63D000E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13D433-04EB-4BF7-93B2-BEAB288882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26306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2" Type="http://schemas.openxmlformats.org/officeDocument/2006/relationships/hyperlink" Target="https://upload.wikimedia.org/wikipedia/commons/a/a5/Beginning_of_Necrotizing_Fasciitis_01.jpg" TargetMode="Externa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hyperlink" Target="https://upload.wikimedia.org/wikipedia/commons/c/c8/Chest_Xray_PA_3-8-2010.png" TargetMode="Externa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D974FA-5548-462B-8746-CDEE9EC1CB6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omplete blood count (CBC)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F4F6BFC-C1A3-455C-BF02-017B7902118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dirty="0"/>
              <a:t>White blood count (WBC)  	 21.0 x1000/mm</a:t>
            </a:r>
            <a:r>
              <a:rPr lang="en-US" baseline="30000" dirty="0"/>
              <a:t>3</a:t>
            </a:r>
            <a:endParaRPr lang="en-US" dirty="0"/>
          </a:p>
          <a:p>
            <a:pPr marL="0" indent="0">
              <a:buNone/>
            </a:pPr>
            <a:r>
              <a:rPr lang="en-US" dirty="0"/>
              <a:t>Hemoglobin (Hgb)    		 11.0 g/dL </a:t>
            </a:r>
          </a:p>
          <a:p>
            <a:pPr marL="0" indent="0">
              <a:buNone/>
            </a:pPr>
            <a:r>
              <a:rPr lang="en-US" dirty="0"/>
              <a:t>Hematocrit (HCT)   		 33.0% </a:t>
            </a:r>
          </a:p>
          <a:p>
            <a:pPr marL="0" indent="0">
              <a:buNone/>
            </a:pPr>
            <a:r>
              <a:rPr lang="en-US" dirty="0"/>
              <a:t>Platelet (</a:t>
            </a:r>
            <a:r>
              <a:rPr lang="en-US" dirty="0" err="1"/>
              <a:t>Plt</a:t>
            </a:r>
            <a:r>
              <a:rPr lang="en-US" dirty="0"/>
              <a:t>)   			 450 x1000/mm</a:t>
            </a:r>
            <a:r>
              <a:rPr lang="en-US" baseline="30000" dirty="0"/>
              <a:t>3</a:t>
            </a:r>
            <a:r>
              <a:rPr lang="en-US" dirty="0"/>
              <a:t>  </a:t>
            </a:r>
          </a:p>
          <a:p>
            <a:pPr marL="0" indent="0">
              <a:buNone/>
            </a:pPr>
            <a:r>
              <a:rPr lang="en-US" dirty="0"/>
              <a:t>Segs:					 70%</a:t>
            </a:r>
          </a:p>
          <a:p>
            <a:pPr marL="0" indent="0">
              <a:buNone/>
            </a:pPr>
            <a:r>
              <a:rPr lang="en-US" dirty="0"/>
              <a:t>Bands:				 15%</a:t>
            </a:r>
          </a:p>
        </p:txBody>
      </p:sp>
    </p:spTree>
    <p:extLst>
      <p:ext uri="{BB962C8B-B14F-4D97-AF65-F5344CB8AC3E}">
        <p14:creationId xmlns:p14="http://schemas.microsoft.com/office/powerpoint/2010/main" val="42972430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Gross gas within ...">
            <a:extLst>
              <a:ext uri="{FF2B5EF4-FFF2-40B4-BE49-F238E27FC236}">
                <a16:creationId xmlns:a16="http://schemas.microsoft.com/office/drawing/2014/main" id="{09B4A1F1-619D-4B41-B56C-9680906ABDAC}"/>
              </a:ext>
            </a:extLst>
          </p:cNvPr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09831" y="0"/>
            <a:ext cx="5972338" cy="6858000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1304308975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4C2DE7D5-687E-4751-BA37-2ED3CB68EC52}"/>
              </a:ext>
            </a:extLst>
          </p:cNvPr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74423" y="62702"/>
            <a:ext cx="5643154" cy="6795298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2861996021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hlinkClick r:id="rId2"/>
            <a:extLst>
              <a:ext uri="{FF2B5EF4-FFF2-40B4-BE49-F238E27FC236}">
                <a16:creationId xmlns:a16="http://schemas.microsoft.com/office/drawing/2014/main" id="{1923E43C-86B3-42BA-BD16-C48DCE53D945}"/>
              </a:ext>
            </a:extLst>
          </p:cNvPr>
          <p:cNvPicPr/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47761" y="365125"/>
            <a:ext cx="4696478" cy="6244699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291698490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F99940-3665-410C-9BAF-97D82B7DA0F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Basic Metabolic Panel (BMP)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6970240-D7B0-4520-9334-97291419AEA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dirty="0"/>
              <a:t>Sodium     				 138 </a:t>
            </a:r>
            <a:r>
              <a:rPr lang="en-US" dirty="0" err="1"/>
              <a:t>mEq</a:t>
            </a:r>
            <a:r>
              <a:rPr lang="en-US" dirty="0"/>
              <a:t>/L </a:t>
            </a:r>
          </a:p>
          <a:p>
            <a:pPr marL="0" indent="0">
              <a:buNone/>
            </a:pPr>
            <a:r>
              <a:rPr lang="en-US" dirty="0"/>
              <a:t>Chloride   				 100 </a:t>
            </a:r>
            <a:r>
              <a:rPr lang="en-US" dirty="0" err="1"/>
              <a:t>mEq</a:t>
            </a:r>
            <a:r>
              <a:rPr lang="en-US" dirty="0"/>
              <a:t>/L </a:t>
            </a:r>
          </a:p>
          <a:p>
            <a:pPr marL="0" indent="0">
              <a:buNone/>
            </a:pPr>
            <a:r>
              <a:rPr lang="en-US" dirty="0"/>
              <a:t>Potassium   				 4.2 </a:t>
            </a:r>
            <a:r>
              <a:rPr lang="en-US" dirty="0" err="1"/>
              <a:t>mEq</a:t>
            </a:r>
            <a:r>
              <a:rPr lang="en-US" dirty="0"/>
              <a:t>/L </a:t>
            </a:r>
          </a:p>
          <a:p>
            <a:pPr marL="0" indent="0">
              <a:buNone/>
            </a:pPr>
            <a:r>
              <a:rPr lang="en-US" dirty="0"/>
              <a:t>Bicarbonate (HCO</a:t>
            </a:r>
            <a:r>
              <a:rPr lang="en-US" baseline="-25000" dirty="0"/>
              <a:t>3</a:t>
            </a:r>
            <a:r>
              <a:rPr lang="en-US" dirty="0"/>
              <a:t>) 		 12 </a:t>
            </a:r>
            <a:r>
              <a:rPr lang="en-US" dirty="0" err="1"/>
              <a:t>mEq</a:t>
            </a:r>
            <a:r>
              <a:rPr lang="en-US" dirty="0"/>
              <a:t>/L  </a:t>
            </a:r>
          </a:p>
          <a:p>
            <a:pPr marL="0" indent="0">
              <a:buNone/>
            </a:pPr>
            <a:r>
              <a:rPr lang="en-US" dirty="0"/>
              <a:t>Blood Urea Nitrogen (BUN) 	 60 mg/dL   </a:t>
            </a:r>
          </a:p>
          <a:p>
            <a:pPr marL="0" indent="0">
              <a:buNone/>
            </a:pPr>
            <a:r>
              <a:rPr lang="en-US" dirty="0"/>
              <a:t>Creatinine (Cr)    			 2.2 mg/dL  </a:t>
            </a:r>
          </a:p>
          <a:p>
            <a:pPr marL="0" indent="0">
              <a:buNone/>
            </a:pPr>
            <a:r>
              <a:rPr lang="en-US" dirty="0"/>
              <a:t>Glucose    				 118 mg/dL </a:t>
            </a:r>
          </a:p>
          <a:p>
            <a:pPr marL="0" indent="0">
              <a:buNone/>
            </a:pPr>
            <a:r>
              <a:rPr lang="en-US" dirty="0"/>
              <a:t>Calcium				 8.0 mg/dL</a:t>
            </a:r>
          </a:p>
        </p:txBody>
      </p:sp>
    </p:spTree>
    <p:extLst>
      <p:ext uri="{BB962C8B-B14F-4D97-AF65-F5344CB8AC3E}">
        <p14:creationId xmlns:p14="http://schemas.microsoft.com/office/powerpoint/2010/main" val="140047001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F3A77C0-0F13-4E02-9670-804D2AF45AC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Liver Function Panel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CEEAA29-9D97-4325-9175-1F803EC738F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marL="0" indent="0">
              <a:buNone/>
            </a:pPr>
            <a:r>
              <a:rPr lang="en-US" dirty="0"/>
              <a:t>AST 				30 Units/L</a:t>
            </a:r>
          </a:p>
          <a:p>
            <a:pPr marL="0" indent="0">
              <a:buNone/>
            </a:pPr>
            <a:r>
              <a:rPr lang="en-US" dirty="0"/>
              <a:t>ALT 				40 Units/L</a:t>
            </a:r>
          </a:p>
          <a:p>
            <a:pPr marL="0" indent="0">
              <a:buNone/>
            </a:pPr>
            <a:r>
              <a:rPr lang="en-US" dirty="0"/>
              <a:t>T </a:t>
            </a:r>
            <a:r>
              <a:rPr lang="en-US" dirty="0" err="1"/>
              <a:t>bili</a:t>
            </a:r>
            <a:r>
              <a:rPr lang="en-US" dirty="0"/>
              <a:t> 				0.8 mg/dL</a:t>
            </a:r>
          </a:p>
          <a:p>
            <a:pPr marL="0" indent="0">
              <a:buNone/>
            </a:pPr>
            <a:r>
              <a:rPr lang="en-US" dirty="0"/>
              <a:t>D </a:t>
            </a:r>
            <a:r>
              <a:rPr lang="en-US" dirty="0" err="1"/>
              <a:t>bili</a:t>
            </a:r>
            <a:r>
              <a:rPr lang="en-US" dirty="0"/>
              <a:t> 				0.2 mg/dL</a:t>
            </a:r>
          </a:p>
          <a:p>
            <a:pPr marL="0" indent="0">
              <a:buNone/>
            </a:pPr>
            <a:r>
              <a:rPr lang="en-US" dirty="0"/>
              <a:t>Albumin 			3.0 g/dL</a:t>
            </a:r>
          </a:p>
          <a:p>
            <a:pPr marL="0" indent="0">
              <a:buNone/>
            </a:pPr>
            <a:r>
              <a:rPr lang="en-US" dirty="0" err="1"/>
              <a:t>Alk</a:t>
            </a:r>
            <a:r>
              <a:rPr lang="en-US" dirty="0"/>
              <a:t> </a:t>
            </a:r>
            <a:r>
              <a:rPr lang="en-US" dirty="0" err="1"/>
              <a:t>Phos</a:t>
            </a:r>
            <a:r>
              <a:rPr lang="en-US" dirty="0"/>
              <a:t> 			100 Units/L</a:t>
            </a:r>
          </a:p>
          <a:p>
            <a:pPr marL="0" indent="0">
              <a:buNone/>
            </a:pPr>
            <a:r>
              <a:rPr lang="en-US" dirty="0"/>
              <a:t>Tot </a:t>
            </a:r>
            <a:r>
              <a:rPr lang="en-US" dirty="0" err="1"/>
              <a:t>Prot</a:t>
            </a:r>
            <a:r>
              <a:rPr lang="en-US" dirty="0"/>
              <a:t> 			7.0 g/dL</a:t>
            </a:r>
          </a:p>
          <a:p>
            <a:pPr marL="0" indent="0">
              <a:buNone/>
            </a:pPr>
            <a:endParaRPr lang="en-US" sz="4400" dirty="0"/>
          </a:p>
        </p:txBody>
      </p:sp>
    </p:spTree>
    <p:extLst>
      <p:ext uri="{BB962C8B-B14F-4D97-AF65-F5344CB8AC3E}">
        <p14:creationId xmlns:p14="http://schemas.microsoft.com/office/powerpoint/2010/main" val="381719546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7F2581-E706-4F96-8284-F8872058CC0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Lactat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1BB77C5-7887-4C1B-88A0-617E8FF4A49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marL="0" indent="0">
              <a:buNone/>
            </a:pPr>
            <a:r>
              <a:rPr lang="en-US" sz="4400" dirty="0"/>
              <a:t>4.1 mmol/L</a:t>
            </a:r>
          </a:p>
        </p:txBody>
      </p:sp>
    </p:spTree>
    <p:extLst>
      <p:ext uri="{BB962C8B-B14F-4D97-AF65-F5344CB8AC3E}">
        <p14:creationId xmlns:p14="http://schemas.microsoft.com/office/powerpoint/2010/main" val="85853544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329792-9B67-4CD1-9C62-8FA0AA5BE7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reatine Kinas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967B54A-C21C-4AF7-A44A-94DD1BA0BAF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marL="0" indent="0">
              <a:buNone/>
            </a:pPr>
            <a:r>
              <a:rPr lang="en-US" sz="3600" dirty="0"/>
              <a:t>457 U/L</a:t>
            </a:r>
          </a:p>
        </p:txBody>
      </p:sp>
    </p:spTree>
    <p:extLst>
      <p:ext uri="{BB962C8B-B14F-4D97-AF65-F5344CB8AC3E}">
        <p14:creationId xmlns:p14="http://schemas.microsoft.com/office/powerpoint/2010/main" val="275132211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1E6FC2-53D4-44E5-BCBF-AF61934A8E9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Venous Blood Ga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7DFD908-E26D-40FE-B9FD-2D9E25C7857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marL="0" indent="0">
              <a:buNone/>
            </a:pPr>
            <a:r>
              <a:rPr lang="en-US" sz="3600" dirty="0"/>
              <a:t>pH      	    		7.25</a:t>
            </a:r>
          </a:p>
          <a:p>
            <a:pPr marL="0" indent="0">
              <a:buNone/>
            </a:pPr>
            <a:r>
              <a:rPr lang="en-US" sz="3600" dirty="0"/>
              <a:t>pCO</a:t>
            </a:r>
            <a:r>
              <a:rPr lang="en-US" sz="3600" baseline="-25000" dirty="0"/>
              <a:t>2</a:t>
            </a:r>
            <a:r>
              <a:rPr lang="en-US" sz="3600" dirty="0"/>
              <a:t>     			30 mmHg</a:t>
            </a:r>
          </a:p>
          <a:p>
            <a:pPr marL="0" indent="0">
              <a:buNone/>
            </a:pPr>
            <a:r>
              <a:rPr lang="en-US" sz="3600" dirty="0"/>
              <a:t>pO</a:t>
            </a:r>
            <a:r>
              <a:rPr lang="en-US" sz="3600" baseline="-25000" dirty="0"/>
              <a:t>2</a:t>
            </a:r>
            <a:r>
              <a:rPr lang="en-US" sz="3600" dirty="0"/>
              <a:t>        			60 mmHg</a:t>
            </a:r>
          </a:p>
          <a:p>
            <a:pPr marL="0" indent="0">
              <a:buNone/>
            </a:pPr>
            <a:r>
              <a:rPr lang="en-US" sz="3600" dirty="0"/>
              <a:t>HCO</a:t>
            </a:r>
            <a:r>
              <a:rPr lang="en-US" sz="3600" baseline="-25000" dirty="0"/>
              <a:t>3</a:t>
            </a:r>
            <a:r>
              <a:rPr lang="en-US" sz="3600" dirty="0"/>
              <a:t>  		         12 </a:t>
            </a:r>
            <a:r>
              <a:rPr lang="en-US" sz="3600" dirty="0" err="1"/>
              <a:t>mEq</a:t>
            </a:r>
            <a:r>
              <a:rPr lang="en-US" sz="3600" dirty="0"/>
              <a:t>/L</a:t>
            </a:r>
          </a:p>
          <a:p>
            <a:pPr marL="0" indent="0">
              <a:buNone/>
            </a:pPr>
            <a:r>
              <a:rPr lang="en-US" sz="3600" dirty="0"/>
              <a:t>O</a:t>
            </a:r>
            <a:r>
              <a:rPr lang="en-US" sz="3600" baseline="-25000" dirty="0"/>
              <a:t>2</a:t>
            </a:r>
            <a:r>
              <a:rPr lang="en-US" sz="3600" dirty="0"/>
              <a:t> Saturation           98% on room air</a:t>
            </a:r>
          </a:p>
          <a:p>
            <a:pPr marL="0" indent="0">
              <a:buNone/>
            </a:pPr>
            <a:endParaRPr lang="en-US" sz="3600" dirty="0"/>
          </a:p>
        </p:txBody>
      </p:sp>
    </p:spTree>
    <p:extLst>
      <p:ext uri="{BB962C8B-B14F-4D97-AF65-F5344CB8AC3E}">
        <p14:creationId xmlns:p14="http://schemas.microsoft.com/office/powerpoint/2010/main" val="188057238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21CB38-71E4-4DAF-88FA-9FCBF64F017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Urinalysi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AF54E85-E901-4F35-B454-B6AAAEC7BD7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 fontScale="92500" lnSpcReduction="20000"/>
          </a:bodyPr>
          <a:lstStyle/>
          <a:p>
            <a:pPr marL="0" indent="0">
              <a:buNone/>
            </a:pPr>
            <a:r>
              <a:rPr lang="en-US" dirty="0"/>
              <a:t>Leukocyte esterase 			negative</a:t>
            </a:r>
          </a:p>
          <a:p>
            <a:pPr marL="0" indent="0">
              <a:buNone/>
            </a:pPr>
            <a:r>
              <a:rPr lang="en-US" dirty="0"/>
              <a:t>Nitrites				negative</a:t>
            </a:r>
          </a:p>
          <a:p>
            <a:pPr marL="0" indent="0">
              <a:buNone/>
            </a:pPr>
            <a:r>
              <a:rPr lang="en-US" dirty="0"/>
              <a:t>Blood 					none</a:t>
            </a:r>
          </a:p>
          <a:p>
            <a:pPr marL="0" indent="0">
              <a:buNone/>
            </a:pPr>
            <a:r>
              <a:rPr lang="en-US" dirty="0"/>
              <a:t>Ketones 				2+</a:t>
            </a:r>
          </a:p>
          <a:p>
            <a:pPr marL="0" indent="0">
              <a:buNone/>
            </a:pPr>
            <a:r>
              <a:rPr lang="en-US" dirty="0"/>
              <a:t>Glucose 				none</a:t>
            </a:r>
          </a:p>
          <a:p>
            <a:pPr marL="0" indent="0">
              <a:buNone/>
            </a:pPr>
            <a:r>
              <a:rPr lang="en-US" dirty="0"/>
              <a:t>Color 					dark yellow</a:t>
            </a:r>
          </a:p>
          <a:p>
            <a:pPr marL="0" indent="0">
              <a:buNone/>
            </a:pPr>
            <a:r>
              <a:rPr lang="en-US" dirty="0"/>
              <a:t>WBC 					0-5 WBCs/HPF</a:t>
            </a:r>
          </a:p>
          <a:p>
            <a:pPr marL="0" indent="0">
              <a:buNone/>
            </a:pPr>
            <a:r>
              <a:rPr lang="en-US" dirty="0"/>
              <a:t>RBC 					5-10 RBCs/HPF</a:t>
            </a:r>
          </a:p>
          <a:p>
            <a:pPr marL="0" indent="0">
              <a:buNone/>
            </a:pPr>
            <a:r>
              <a:rPr lang="en-US" dirty="0"/>
              <a:t>Squamous epithelial cells 		0-5 cells/HPF</a:t>
            </a:r>
          </a:p>
          <a:p>
            <a:pPr marL="0" indent="0">
              <a:buNone/>
            </a:pPr>
            <a:r>
              <a:rPr lang="en-US" dirty="0"/>
              <a:t>Specific gravity 			1.015</a:t>
            </a:r>
          </a:p>
        </p:txBody>
      </p:sp>
    </p:spTree>
    <p:extLst>
      <p:ext uri="{BB962C8B-B14F-4D97-AF65-F5344CB8AC3E}">
        <p14:creationId xmlns:p14="http://schemas.microsoft.com/office/powerpoint/2010/main" val="330209603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8ECFBAF-7DC3-48B8-9F96-437323C4A6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C5ACB08-BD63-4930-A147-20F867D2450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marL="0" indent="0">
              <a:buNone/>
            </a:pPr>
            <a:endParaRPr lang="en-US" sz="4400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C617A9DB-AC11-4E62-A7D1-2A5F87F3EF4A}"/>
              </a:ext>
            </a:extLst>
          </p:cNvPr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026" y="198555"/>
            <a:ext cx="12064855" cy="6294320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419837807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0C5EB8-B3B4-42E5-BA08-3ABA912B675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5D02C2C-9FD0-4188-B56A-5F95699500C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marL="0" indent="0">
              <a:buNone/>
            </a:pPr>
            <a:endParaRPr lang="en-US" dirty="0"/>
          </a:p>
        </p:txBody>
      </p:sp>
      <p:pic>
        <p:nvPicPr>
          <p:cNvPr id="4" name="Picture 3">
            <a:hlinkClick r:id="rId2"/>
            <a:extLst>
              <a:ext uri="{FF2B5EF4-FFF2-40B4-BE49-F238E27FC236}">
                <a16:creationId xmlns:a16="http://schemas.microsoft.com/office/drawing/2014/main" id="{FC7CAC01-835F-46C9-8F5C-F5DB0E391168}"/>
              </a:ext>
            </a:extLst>
          </p:cNvPr>
          <p:cNvPicPr/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25337" y="124097"/>
            <a:ext cx="7341326" cy="6609806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36365060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</TotalTime>
  <Words>350</Words>
  <Application>Microsoft Office PowerPoint</Application>
  <PresentationFormat>Widescreen</PresentationFormat>
  <Paragraphs>45</Paragraphs>
  <Slides>1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2</vt:i4>
      </vt:variant>
    </vt:vector>
  </HeadingPairs>
  <TitlesOfParts>
    <vt:vector size="16" baseType="lpstr">
      <vt:lpstr>Arial</vt:lpstr>
      <vt:lpstr>Calibri</vt:lpstr>
      <vt:lpstr>Calibri Light</vt:lpstr>
      <vt:lpstr>Office Theme</vt:lpstr>
      <vt:lpstr>Complete blood count (CBC)</vt:lpstr>
      <vt:lpstr>Basic Metabolic Panel (BMP)</vt:lpstr>
      <vt:lpstr>Liver Function Panel</vt:lpstr>
      <vt:lpstr>Lactate</vt:lpstr>
      <vt:lpstr>Creatine Kinase</vt:lpstr>
      <vt:lpstr>Venous Blood Gas</vt:lpstr>
      <vt:lpstr>Urinalysis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ennifer Yee</dc:creator>
  <cp:lastModifiedBy>Jennifer Yee</cp:lastModifiedBy>
  <cp:revision>40</cp:revision>
  <dcterms:created xsi:type="dcterms:W3CDTF">2019-12-09T13:57:02Z</dcterms:created>
  <dcterms:modified xsi:type="dcterms:W3CDTF">2020-02-21T02:41:36Z</dcterms:modified>
</cp:coreProperties>
</file>